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324" autoAdjust="0"/>
    <p:restoredTop sz="94660"/>
  </p:normalViewPr>
  <p:slideViewPr>
    <p:cSldViewPr>
      <p:cViewPr varScale="1">
        <p:scale>
          <a:sx n="110" d="100"/>
          <a:sy n="110" d="100"/>
        </p:scale>
        <p:origin x="1890" y="10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F:\bZIP\2.&#20154;&#21442;bZIP&#25968;&#25454;\&#21508;&#20010;&#32452;&#32455;&#34920;&#36798;&#37327;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F:\bZIP\2.&#20154;&#21442;bZIP&#25968;&#25454;\&#21508;&#20010;&#32452;&#32455;&#34920;&#36798;&#37327;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F:\bZIP\2.&#20154;&#21442;bZIP&#25968;&#25454;\&#21508;&#20010;&#32452;&#32455;&#34920;&#36798;&#37327;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5359855247333701"/>
          <c:y val="4.8699989943341959E-2"/>
          <c:w val="0.79823808946563002"/>
          <c:h val="0.89838702840715001"/>
        </c:manualLayout>
      </c:layout>
      <c:barChart>
        <c:barDir val="bar"/>
        <c:grouping val="clustered"/>
        <c:varyColors val="0"/>
        <c:ser>
          <c:idx val="0"/>
          <c:order val="0"/>
          <c:invertIfNegative val="0"/>
          <c:cat>
            <c:strRef>
              <c:f>Sheet2!$A$2:$A$43</c:f>
              <c:strCache>
                <c:ptCount val="42"/>
                <c:pt idx="0">
                  <c:v>S1</c:v>
                </c:pt>
                <c:pt idx="1">
                  <c:v>S2</c:v>
                </c:pt>
                <c:pt idx="2">
                  <c:v>S3</c:v>
                </c:pt>
                <c:pt idx="3">
                  <c:v>S4</c:v>
                </c:pt>
                <c:pt idx="4">
                  <c:v>S5</c:v>
                </c:pt>
                <c:pt idx="5">
                  <c:v>S6</c:v>
                </c:pt>
                <c:pt idx="6">
                  <c:v>S7</c:v>
                </c:pt>
                <c:pt idx="7">
                  <c:v>S8</c:v>
                </c:pt>
                <c:pt idx="8">
                  <c:v>S9</c:v>
                </c:pt>
                <c:pt idx="9">
                  <c:v>S10</c:v>
                </c:pt>
                <c:pt idx="10">
                  <c:v>S11</c:v>
                </c:pt>
                <c:pt idx="11">
                  <c:v>S12</c:v>
                </c:pt>
                <c:pt idx="12">
                  <c:v>S13</c:v>
                </c:pt>
                <c:pt idx="13">
                  <c:v>S14</c:v>
                </c:pt>
                <c:pt idx="14">
                  <c:v>S15</c:v>
                </c:pt>
                <c:pt idx="15">
                  <c:v>S16</c:v>
                </c:pt>
                <c:pt idx="16">
                  <c:v>S17</c:v>
                </c:pt>
                <c:pt idx="17">
                  <c:v>S18</c:v>
                </c:pt>
                <c:pt idx="18">
                  <c:v>S19</c:v>
                </c:pt>
                <c:pt idx="19">
                  <c:v>S20</c:v>
                </c:pt>
                <c:pt idx="20">
                  <c:v>S21</c:v>
                </c:pt>
                <c:pt idx="21">
                  <c:v>S22</c:v>
                </c:pt>
                <c:pt idx="22">
                  <c:v>S23</c:v>
                </c:pt>
                <c:pt idx="23">
                  <c:v>S24</c:v>
                </c:pt>
                <c:pt idx="24">
                  <c:v>S25</c:v>
                </c:pt>
                <c:pt idx="25">
                  <c:v>S26</c:v>
                </c:pt>
                <c:pt idx="26">
                  <c:v>S27</c:v>
                </c:pt>
                <c:pt idx="27">
                  <c:v>S28</c:v>
                </c:pt>
                <c:pt idx="28">
                  <c:v>S29</c:v>
                </c:pt>
                <c:pt idx="29">
                  <c:v>S30</c:v>
                </c:pt>
                <c:pt idx="30">
                  <c:v>S31</c:v>
                </c:pt>
                <c:pt idx="31">
                  <c:v>S32</c:v>
                </c:pt>
                <c:pt idx="32">
                  <c:v>S33</c:v>
                </c:pt>
                <c:pt idx="33">
                  <c:v>S34</c:v>
                </c:pt>
                <c:pt idx="34">
                  <c:v>S35</c:v>
                </c:pt>
                <c:pt idx="35">
                  <c:v>S36</c:v>
                </c:pt>
                <c:pt idx="36">
                  <c:v>S37</c:v>
                </c:pt>
                <c:pt idx="37">
                  <c:v>S38</c:v>
                </c:pt>
                <c:pt idx="38">
                  <c:v>S39</c:v>
                </c:pt>
                <c:pt idx="39">
                  <c:v>S40</c:v>
                </c:pt>
                <c:pt idx="40">
                  <c:v>S41</c:v>
                </c:pt>
                <c:pt idx="41">
                  <c:v>S42</c:v>
                </c:pt>
              </c:strCache>
            </c:strRef>
          </c:cat>
          <c:val>
            <c:numRef>
              <c:f>Sheet2!$D$2:$D$43</c:f>
              <c:numCache>
                <c:formatCode>General</c:formatCode>
                <c:ptCount val="42"/>
                <c:pt idx="0">
                  <c:v>49.08424908424908</c:v>
                </c:pt>
                <c:pt idx="1">
                  <c:v>47.252747252747248</c:v>
                </c:pt>
                <c:pt idx="2">
                  <c:v>42.490842490842489</c:v>
                </c:pt>
                <c:pt idx="3">
                  <c:v>45.054945054945058</c:v>
                </c:pt>
                <c:pt idx="4">
                  <c:v>51.282051282051277</c:v>
                </c:pt>
                <c:pt idx="5">
                  <c:v>45.054945054945058</c:v>
                </c:pt>
                <c:pt idx="6">
                  <c:v>50.915750915750912</c:v>
                </c:pt>
                <c:pt idx="7">
                  <c:v>49.450549450549453</c:v>
                </c:pt>
                <c:pt idx="8">
                  <c:v>46.886446886446883</c:v>
                </c:pt>
                <c:pt idx="9">
                  <c:v>47.985347985347985</c:v>
                </c:pt>
                <c:pt idx="10">
                  <c:v>46.520146520146518</c:v>
                </c:pt>
                <c:pt idx="11">
                  <c:v>49.816849816849818</c:v>
                </c:pt>
                <c:pt idx="12">
                  <c:v>43.589743589743591</c:v>
                </c:pt>
                <c:pt idx="13">
                  <c:v>49.816849816849818</c:v>
                </c:pt>
                <c:pt idx="14">
                  <c:v>44.688644688644693</c:v>
                </c:pt>
                <c:pt idx="15">
                  <c:v>46.520146520146518</c:v>
                </c:pt>
                <c:pt idx="16">
                  <c:v>50.915750915750912</c:v>
                </c:pt>
                <c:pt idx="17">
                  <c:v>49.08424908424908</c:v>
                </c:pt>
                <c:pt idx="18">
                  <c:v>47.619047619047613</c:v>
                </c:pt>
                <c:pt idx="19">
                  <c:v>50.549450549450547</c:v>
                </c:pt>
                <c:pt idx="20">
                  <c:v>50.549450549450547</c:v>
                </c:pt>
                <c:pt idx="21">
                  <c:v>38.827838827838832</c:v>
                </c:pt>
                <c:pt idx="22">
                  <c:v>50.183150183150182</c:v>
                </c:pt>
                <c:pt idx="23">
                  <c:v>54.945054945054949</c:v>
                </c:pt>
                <c:pt idx="24">
                  <c:v>47.252747252747248</c:v>
                </c:pt>
                <c:pt idx="25">
                  <c:v>43.956043956043956</c:v>
                </c:pt>
                <c:pt idx="26">
                  <c:v>50.183150183150182</c:v>
                </c:pt>
                <c:pt idx="27">
                  <c:v>51.648351648351657</c:v>
                </c:pt>
                <c:pt idx="28">
                  <c:v>46.886446886446883</c:v>
                </c:pt>
                <c:pt idx="29">
                  <c:v>45.054945054945058</c:v>
                </c:pt>
                <c:pt idx="30">
                  <c:v>49.450549450549453</c:v>
                </c:pt>
                <c:pt idx="31">
                  <c:v>47.985347985347985</c:v>
                </c:pt>
                <c:pt idx="32">
                  <c:v>45.421245421245423</c:v>
                </c:pt>
                <c:pt idx="33">
                  <c:v>49.450549450549453</c:v>
                </c:pt>
                <c:pt idx="34">
                  <c:v>47.985347985347985</c:v>
                </c:pt>
                <c:pt idx="35">
                  <c:v>48.717948717948715</c:v>
                </c:pt>
                <c:pt idx="36">
                  <c:v>47.619047619047613</c:v>
                </c:pt>
                <c:pt idx="37">
                  <c:v>51.648351648351657</c:v>
                </c:pt>
                <c:pt idx="38">
                  <c:v>48.717948717948715</c:v>
                </c:pt>
                <c:pt idx="39">
                  <c:v>46.153846153846153</c:v>
                </c:pt>
                <c:pt idx="40">
                  <c:v>45.054945054945058</c:v>
                </c:pt>
                <c:pt idx="41">
                  <c:v>49.0842490842490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066C-4F81-8E18-9850F85B425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58421336"/>
        <c:axId val="158422512"/>
      </c:barChart>
      <c:catAx>
        <c:axId val="158421336"/>
        <c:scaling>
          <c:orientation val="minMax"/>
        </c:scaling>
        <c:delete val="0"/>
        <c:axPos val="l"/>
        <c:numFmt formatCode="General" sourceLinked="0"/>
        <c:majorTickMark val="out"/>
        <c:minorTickMark val="none"/>
        <c:tickLblPos val="nextTo"/>
        <c:crossAx val="158422512"/>
        <c:crosses val="autoZero"/>
        <c:auto val="1"/>
        <c:lblAlgn val="ctr"/>
        <c:lblOffset val="100"/>
        <c:noMultiLvlLbl val="0"/>
      </c:catAx>
      <c:valAx>
        <c:axId val="15842251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58421336"/>
        <c:crosses val="autoZero"/>
        <c:crossBetween val="between"/>
        <c:majorUnit val="10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bar"/>
        <c:grouping val="clustered"/>
        <c:varyColors val="0"/>
        <c:ser>
          <c:idx val="0"/>
          <c:order val="0"/>
          <c:invertIfNegative val="0"/>
          <c:cat>
            <c:strRef>
              <c:f>Sheet2!$A$44:$A$57</c:f>
              <c:strCache>
                <c:ptCount val="14"/>
                <c:pt idx="0">
                  <c:v>Fiber root</c:v>
                </c:pt>
                <c:pt idx="1">
                  <c:v>Leg root</c:v>
                </c:pt>
                <c:pt idx="2">
                  <c:v>Main root epiderm</c:v>
                </c:pt>
                <c:pt idx="3">
                  <c:v>Main root cortex</c:v>
                </c:pt>
                <c:pt idx="4">
                  <c:v>Rhizome</c:v>
                </c:pt>
                <c:pt idx="5">
                  <c:v>Arm root</c:v>
                </c:pt>
                <c:pt idx="6">
                  <c:v>Stem</c:v>
                </c:pt>
                <c:pt idx="7">
                  <c:v>Leaf peduncle</c:v>
                </c:pt>
                <c:pt idx="8">
                  <c:v>Leaflet pedicel</c:v>
                </c:pt>
                <c:pt idx="9">
                  <c:v>Leaf blade</c:v>
                </c:pt>
                <c:pt idx="10">
                  <c:v>Fruit peduncle</c:v>
                </c:pt>
                <c:pt idx="11">
                  <c:v>Fruit pedicel</c:v>
                </c:pt>
                <c:pt idx="12">
                  <c:v>Fruit flesh</c:v>
                </c:pt>
                <c:pt idx="13">
                  <c:v>Seed</c:v>
                </c:pt>
              </c:strCache>
            </c:strRef>
          </c:cat>
          <c:val>
            <c:numRef>
              <c:f>Sheet2!$D$44:$D$57</c:f>
              <c:numCache>
                <c:formatCode>General</c:formatCode>
                <c:ptCount val="14"/>
                <c:pt idx="0">
                  <c:v>47.619047619047613</c:v>
                </c:pt>
                <c:pt idx="1">
                  <c:v>52.747252747252752</c:v>
                </c:pt>
                <c:pt idx="2">
                  <c:v>46.520146520146518</c:v>
                </c:pt>
                <c:pt idx="3">
                  <c:v>47.985347985347985</c:v>
                </c:pt>
                <c:pt idx="4">
                  <c:v>55.311355311355314</c:v>
                </c:pt>
                <c:pt idx="5">
                  <c:v>49.08424908424908</c:v>
                </c:pt>
                <c:pt idx="6">
                  <c:v>55.311355311355314</c:v>
                </c:pt>
                <c:pt idx="7">
                  <c:v>52.014652014652022</c:v>
                </c:pt>
                <c:pt idx="8">
                  <c:v>53.479853479853482</c:v>
                </c:pt>
                <c:pt idx="9">
                  <c:v>48.717948717948715</c:v>
                </c:pt>
                <c:pt idx="10">
                  <c:v>52.014652014652022</c:v>
                </c:pt>
                <c:pt idx="11">
                  <c:v>66.300366300366292</c:v>
                </c:pt>
                <c:pt idx="12">
                  <c:v>54.212454212454212</c:v>
                </c:pt>
                <c:pt idx="13">
                  <c:v>51.28205128205127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0A3D-4385-9569-DA2D62DD760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60945040"/>
        <c:axId val="160947000"/>
      </c:barChart>
      <c:catAx>
        <c:axId val="16094504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en-US"/>
          </a:p>
        </c:txPr>
        <c:crossAx val="160947000"/>
        <c:crosses val="autoZero"/>
        <c:auto val="1"/>
        <c:lblAlgn val="ctr"/>
        <c:lblOffset val="100"/>
        <c:noMultiLvlLbl val="0"/>
      </c:catAx>
      <c:valAx>
        <c:axId val="16094700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 algn="ctr">
              <a:defRPr lang="zh-CN" altLang="en-US" sz="10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60945040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bar"/>
        <c:grouping val="clustered"/>
        <c:varyColors val="0"/>
        <c:ser>
          <c:idx val="0"/>
          <c:order val="0"/>
          <c:invertIfNegative val="0"/>
          <c:cat>
            <c:strRef>
              <c:f>Sheet2!$A$58:$A$61</c:f>
              <c:strCache>
                <c:ptCount val="4"/>
                <c:pt idx="0">
                  <c:v>5-year-old root</c:v>
                </c:pt>
                <c:pt idx="1">
                  <c:v>12-year-old root</c:v>
                </c:pt>
                <c:pt idx="2">
                  <c:v>18-year-old root</c:v>
                </c:pt>
                <c:pt idx="3">
                  <c:v>25-year-old root</c:v>
                </c:pt>
              </c:strCache>
            </c:strRef>
          </c:cat>
          <c:val>
            <c:numRef>
              <c:f>Sheet2!$D$58:$D$61</c:f>
              <c:numCache>
                <c:formatCode>General</c:formatCode>
                <c:ptCount val="4"/>
                <c:pt idx="0">
                  <c:v>47.985347985347985</c:v>
                </c:pt>
                <c:pt idx="1">
                  <c:v>43.956043956043956</c:v>
                </c:pt>
                <c:pt idx="2">
                  <c:v>45.787545787545788</c:v>
                </c:pt>
                <c:pt idx="3">
                  <c:v>47.61904761904761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0725-4A55-B365-B521204E939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60945432"/>
        <c:axId val="160947392"/>
      </c:barChart>
      <c:catAx>
        <c:axId val="160945432"/>
        <c:scaling>
          <c:orientation val="minMax"/>
        </c:scaling>
        <c:delete val="0"/>
        <c:axPos val="l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en-US"/>
          </a:p>
        </c:txPr>
        <c:crossAx val="160947392"/>
        <c:crosses val="autoZero"/>
        <c:auto val="1"/>
        <c:lblAlgn val="ctr"/>
        <c:lblOffset val="100"/>
        <c:noMultiLvlLbl val="0"/>
      </c:catAx>
      <c:valAx>
        <c:axId val="160947392"/>
        <c:scaling>
          <c:orientation val="minMax"/>
          <c:max val="50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en-US"/>
          </a:p>
        </c:txPr>
        <c:crossAx val="160945432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E96763-C61C-40E1-8408-70CD6D0F063D}" type="datetimeFigureOut">
              <a:rPr lang="zh-CN" altLang="en-US" smtClean="0"/>
              <a:t>2021/3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86CA90-9A50-4AFE-A8C4-C2603E0275C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617576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E96763-C61C-40E1-8408-70CD6D0F063D}" type="datetimeFigureOut">
              <a:rPr lang="zh-CN" altLang="en-US" smtClean="0"/>
              <a:t>2021/3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86CA90-9A50-4AFE-A8C4-C2603E0275C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1803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E96763-C61C-40E1-8408-70CD6D0F063D}" type="datetimeFigureOut">
              <a:rPr lang="zh-CN" altLang="en-US" smtClean="0"/>
              <a:t>2021/3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86CA90-9A50-4AFE-A8C4-C2603E0275C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213877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E96763-C61C-40E1-8408-70CD6D0F063D}" type="datetimeFigureOut">
              <a:rPr lang="zh-CN" altLang="en-US" smtClean="0"/>
              <a:t>2021/3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86CA90-9A50-4AFE-A8C4-C2603E0275C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940780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E96763-C61C-40E1-8408-70CD6D0F063D}" type="datetimeFigureOut">
              <a:rPr lang="zh-CN" altLang="en-US" smtClean="0"/>
              <a:t>2021/3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86CA90-9A50-4AFE-A8C4-C2603E0275C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273654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E96763-C61C-40E1-8408-70CD6D0F063D}" type="datetimeFigureOut">
              <a:rPr lang="zh-CN" altLang="en-US" smtClean="0"/>
              <a:t>2021/3/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86CA90-9A50-4AFE-A8C4-C2603E0275C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37678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E96763-C61C-40E1-8408-70CD6D0F063D}" type="datetimeFigureOut">
              <a:rPr lang="zh-CN" altLang="en-US" smtClean="0"/>
              <a:t>2021/3/5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86CA90-9A50-4AFE-A8C4-C2603E0275C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256500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E96763-C61C-40E1-8408-70CD6D0F063D}" type="datetimeFigureOut">
              <a:rPr lang="zh-CN" altLang="en-US" smtClean="0"/>
              <a:t>2021/3/5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86CA90-9A50-4AFE-A8C4-C2603E0275C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945071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E96763-C61C-40E1-8408-70CD6D0F063D}" type="datetimeFigureOut">
              <a:rPr lang="zh-CN" altLang="en-US" smtClean="0"/>
              <a:t>2021/3/5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86CA90-9A50-4AFE-A8C4-C2603E0275C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476801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E96763-C61C-40E1-8408-70CD6D0F063D}" type="datetimeFigureOut">
              <a:rPr lang="zh-CN" altLang="en-US" smtClean="0"/>
              <a:t>2021/3/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86CA90-9A50-4AFE-A8C4-C2603E0275C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825632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E96763-C61C-40E1-8408-70CD6D0F063D}" type="datetimeFigureOut">
              <a:rPr lang="zh-CN" altLang="en-US" smtClean="0"/>
              <a:t>2021/3/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86CA90-9A50-4AFE-A8C4-C2603E0275C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328311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E96763-C61C-40E1-8408-70CD6D0F063D}" type="datetimeFigureOut">
              <a:rPr lang="zh-CN" altLang="en-US" smtClean="0"/>
              <a:t>2021/3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86CA90-9A50-4AFE-A8C4-C2603E0275C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027302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标题 1"/>
          <p:cNvSpPr txBox="1">
            <a:spLocks/>
          </p:cNvSpPr>
          <p:nvPr/>
        </p:nvSpPr>
        <p:spPr>
          <a:xfrm>
            <a:off x="902395" y="5552490"/>
            <a:ext cx="6981973" cy="504056"/>
          </a:xfrm>
          <a:prstGeom prst="rect">
            <a:avLst/>
          </a:prstGeom>
        </p:spPr>
        <p:txBody>
          <a:bodyPr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just"/>
            <a:r>
              <a:rPr lang="en-US" altLang="zh-CN" sz="1200" b="1" dirty="0" smtClean="0">
                <a:latin typeface="Times New Roman" pitchFamily="18" charset="0"/>
                <a:cs typeface="Times New Roman" pitchFamily="18" charset="0"/>
              </a:rPr>
              <a:t>Fig. S3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Percentage of the 273 </a:t>
            </a:r>
            <a:r>
              <a:rPr lang="en-US" altLang="zh-CN" sz="1200" i="1" dirty="0" err="1">
                <a:latin typeface="Times New Roman" pitchFamily="18" charset="0"/>
                <a:cs typeface="Times New Roman" pitchFamily="18" charset="0"/>
              </a:rPr>
              <a:t>PgbZIP</a:t>
            </a:r>
            <a:r>
              <a:rPr lang="en-US" altLang="zh-CN" sz="1200" i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transcripts expressed in different tissues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(</a:t>
            </a:r>
            <a:r>
              <a:rPr lang="en-US" altLang="zh-CN" sz="1200" b="1" dirty="0" smtClean="0">
                <a:latin typeface="Times New Roman" pitchFamily="18" charset="0"/>
                <a:cs typeface="Times New Roman" pitchFamily="18" charset="0"/>
              </a:rPr>
              <a:t>a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)</a:t>
            </a:r>
            <a:r>
              <a:rPr lang="en-US" altLang="zh-CN" sz="1200" b="1" dirty="0" smtClean="0">
                <a:latin typeface="Times New Roman" pitchFamily="18" charset="0"/>
                <a:cs typeface="Times New Roman" pitchFamily="18" charset="0"/>
              </a:rPr>
              <a:t>,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 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in the roots of differently aged plants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(</a:t>
            </a:r>
            <a:r>
              <a:rPr lang="en-US" altLang="zh-CN" sz="1200" b="1" dirty="0" smtClean="0">
                <a:latin typeface="Times New Roman" pitchFamily="18" charset="0"/>
                <a:cs typeface="Times New Roman" pitchFamily="18" charset="0"/>
              </a:rPr>
              <a:t>b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)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,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in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the four-year-old roots of different genotypes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(</a:t>
            </a:r>
            <a:r>
              <a:rPr lang="en-US" altLang="zh-CN" sz="1200" b="1" dirty="0" smtClean="0">
                <a:latin typeface="Times New Roman" pitchFamily="18" charset="0"/>
                <a:cs typeface="Times New Roman" pitchFamily="18" charset="0"/>
              </a:rPr>
              <a:t>c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). </a:t>
            </a:r>
            <a:endParaRPr lang="zh-CN" altLang="zh-CN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1" name="Rectangle 40"/>
          <p:cNvSpPr/>
          <p:nvPr/>
        </p:nvSpPr>
        <p:spPr>
          <a:xfrm>
            <a:off x="5494023" y="5277166"/>
            <a:ext cx="1893702" cy="24006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just">
              <a:lnSpc>
                <a:spcPct val="120000"/>
              </a:lnSpc>
              <a:defRPr/>
            </a:pPr>
            <a:r>
              <a:rPr lang="en-US" altLang="zh-CN" sz="8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Percentage of the </a:t>
            </a:r>
            <a:r>
              <a:rPr lang="en-US" altLang="zh-CN" sz="800" i="1" dirty="0" err="1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Pg</a:t>
            </a:r>
            <a:r>
              <a:rPr lang="en-US" altLang="zh-CN" sz="800" i="1" dirty="0" err="1">
                <a:solidFill>
                  <a:prstClr val="black"/>
                </a:solidFill>
                <a:latin typeface="Times New Roman" pitchFamily="18" charset="0"/>
                <a:ea typeface="宋体" panose="02010600030101010101" pitchFamily="2" charset="-122"/>
                <a:cs typeface="Times New Roman" pitchFamily="18" charset="0"/>
              </a:rPr>
              <a:t>bZIP</a:t>
            </a:r>
            <a:r>
              <a:rPr lang="en-US" altLang="zh-CN" sz="8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transcripts</a:t>
            </a:r>
          </a:p>
        </p:txBody>
      </p:sp>
      <p:sp>
        <p:nvSpPr>
          <p:cNvPr id="37" name="TextBox 36"/>
          <p:cNvSpPr txBox="1"/>
          <p:nvPr/>
        </p:nvSpPr>
        <p:spPr>
          <a:xfrm>
            <a:off x="1808271" y="375035"/>
            <a:ext cx="37638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Times New Roman" pitchFamily="18" charset="0"/>
                <a:cs typeface="Times New Roman" pitchFamily="18" charset="0"/>
              </a:rPr>
              <a:t>A</a:t>
            </a:r>
          </a:p>
        </p:txBody>
      </p:sp>
      <p:sp>
        <p:nvSpPr>
          <p:cNvPr id="42" name="Rectangle 41"/>
          <p:cNvSpPr/>
          <p:nvPr/>
        </p:nvSpPr>
        <p:spPr>
          <a:xfrm>
            <a:off x="2153788" y="2903984"/>
            <a:ext cx="1971703" cy="24006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just">
              <a:lnSpc>
                <a:spcPct val="120000"/>
              </a:lnSpc>
              <a:defRPr/>
            </a:pPr>
            <a:r>
              <a:rPr lang="en-US" altLang="zh-CN" sz="8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Percentage of the </a:t>
            </a:r>
            <a:r>
              <a:rPr lang="en-US" altLang="zh-CN" sz="800" i="1" dirty="0" err="1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Pg</a:t>
            </a:r>
            <a:r>
              <a:rPr lang="en-US" altLang="zh-CN" sz="800" i="1" dirty="0" err="1">
                <a:solidFill>
                  <a:prstClr val="black"/>
                </a:solidFill>
                <a:latin typeface="Times New Roman" pitchFamily="18" charset="0"/>
                <a:ea typeface="宋体" panose="02010600030101010101" pitchFamily="2" charset="-122"/>
                <a:cs typeface="Times New Roman" pitchFamily="18" charset="0"/>
              </a:rPr>
              <a:t>bZIP</a:t>
            </a:r>
            <a:r>
              <a:rPr lang="en-US" altLang="zh-CN" sz="8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transcripts</a:t>
            </a:r>
          </a:p>
        </p:txBody>
      </p:sp>
      <p:graphicFrame>
        <p:nvGraphicFramePr>
          <p:cNvPr id="17" name="图表 16">
            <a:extLst>
              <a:ext uri="{FF2B5EF4-FFF2-40B4-BE49-F238E27FC236}">
                <a16:creationId xmlns="" xmlns:a16="http://schemas.microsoft.com/office/drawing/2014/main" id="{00000000-0008-0000-0100-000004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16034683"/>
              </p:ext>
            </p:extLst>
          </p:nvPr>
        </p:nvGraphicFramePr>
        <p:xfrm>
          <a:off x="4725729" y="464434"/>
          <a:ext cx="3027509" cy="481273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9" name="图表 18">
            <a:extLst>
              <a:ext uri="{FF2B5EF4-FFF2-40B4-BE49-F238E27FC236}">
                <a16:creationId xmlns="" xmlns:a16="http://schemas.microsoft.com/office/drawing/2014/main" id="{00000000-0008-0000-0100-000005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65065313"/>
              </p:ext>
            </p:extLst>
          </p:nvPr>
        </p:nvGraphicFramePr>
        <p:xfrm>
          <a:off x="666633" y="498146"/>
          <a:ext cx="3854517" cy="245770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0" name="Rectangle 41">
            <a:extLst>
              <a:ext uri="{FF2B5EF4-FFF2-40B4-BE49-F238E27FC236}">
                <a16:creationId xmlns="" xmlns:a16="http://schemas.microsoft.com/office/drawing/2014/main" id="{CE9223A5-73EF-4C3E-9142-D3CDA4702FBC}"/>
              </a:ext>
            </a:extLst>
          </p:cNvPr>
          <p:cNvSpPr/>
          <p:nvPr/>
        </p:nvSpPr>
        <p:spPr>
          <a:xfrm>
            <a:off x="2184656" y="5256413"/>
            <a:ext cx="1971703" cy="24006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just">
              <a:lnSpc>
                <a:spcPct val="120000"/>
              </a:lnSpc>
              <a:defRPr/>
            </a:pPr>
            <a:r>
              <a:rPr lang="en-US" altLang="zh-CN" sz="8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Percentage of the </a:t>
            </a:r>
            <a:r>
              <a:rPr lang="en-US" altLang="zh-CN" sz="800" i="1" dirty="0" err="1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Pg</a:t>
            </a:r>
            <a:r>
              <a:rPr lang="en-US" altLang="zh-CN" sz="800" i="1" dirty="0" err="1">
                <a:solidFill>
                  <a:prstClr val="black"/>
                </a:solidFill>
                <a:latin typeface="Times New Roman" pitchFamily="18" charset="0"/>
                <a:ea typeface="宋体" panose="02010600030101010101" pitchFamily="2" charset="-122"/>
                <a:cs typeface="Times New Roman" pitchFamily="18" charset="0"/>
              </a:rPr>
              <a:t>bZIP</a:t>
            </a:r>
            <a:r>
              <a:rPr lang="en-US" altLang="zh-CN" sz="8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transcripts</a:t>
            </a:r>
          </a:p>
        </p:txBody>
      </p:sp>
      <p:graphicFrame>
        <p:nvGraphicFramePr>
          <p:cNvPr id="22" name="图表 21">
            <a:extLst>
              <a:ext uri="{FF2B5EF4-FFF2-40B4-BE49-F238E27FC236}">
                <a16:creationId xmlns="" xmlns:a16="http://schemas.microsoft.com/office/drawing/2014/main" id="{00000000-0008-0000-0100-000002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86903703"/>
              </p:ext>
            </p:extLst>
          </p:nvPr>
        </p:nvGraphicFramePr>
        <p:xfrm>
          <a:off x="803456" y="3115392"/>
          <a:ext cx="3717694" cy="220218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3" name="TextBox 12"/>
          <p:cNvSpPr txBox="1"/>
          <p:nvPr/>
        </p:nvSpPr>
        <p:spPr>
          <a:xfrm>
            <a:off x="1876148" y="3037047"/>
            <a:ext cx="2696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Times New Roman" pitchFamily="18" charset="0"/>
                <a:cs typeface="Times New Roman" pitchFamily="18" charset="0"/>
              </a:rPr>
              <a:t>B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5168239" y="397825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C</a:t>
            </a:r>
            <a:endParaRPr 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3978817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27</TotalTime>
  <Words>54</Words>
  <Application>Microsoft Office PowerPoint</Application>
  <PresentationFormat>On-screen Show (4:3)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宋体</vt:lpstr>
      <vt:lpstr>Arial</vt:lpstr>
      <vt:lpstr>Calibri</vt:lpstr>
      <vt:lpstr>Times New Roman</vt:lpstr>
      <vt:lpstr>Office 主题​​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</dc:creator>
  <cp:lastModifiedBy>Zhang, Meiping</cp:lastModifiedBy>
  <cp:revision>68</cp:revision>
  <dcterms:created xsi:type="dcterms:W3CDTF">2016-12-14T13:07:31Z</dcterms:created>
  <dcterms:modified xsi:type="dcterms:W3CDTF">2021-03-05T19:13:34Z</dcterms:modified>
</cp:coreProperties>
</file>